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8" autoAdjust="0"/>
    <p:restoredTop sz="94660"/>
  </p:normalViewPr>
  <p:slideViewPr>
    <p:cSldViewPr snapToGrid="0">
      <p:cViewPr varScale="1">
        <p:scale>
          <a:sx n="77" d="100"/>
          <a:sy n="77" d="100"/>
        </p:scale>
        <p:origin x="306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49888;&#52404;&#54876;&#46041;\240603\PAF&#50836;&#51064;&#48324;&#44536;&#47548;&#44536;&#47532;&#44592;_DPA_Soseul_240625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49888;&#52404;&#54876;&#46041;\240603\PAF&#50836;&#51064;&#48324;&#44536;&#47548;&#44536;&#47532;&#44592;_DPA_Soseul_240625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49888;&#52404;&#54876;&#46041;\240603\PAF&#50836;&#51064;&#48324;&#44536;&#47548;&#44536;&#47532;&#44592;_DPA_Soseul_240625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49888;&#52404;&#54876;&#46041;\240603\PAF&#50836;&#51064;&#48324;&#44536;&#47548;&#44536;&#47532;&#44592;_DPA_Soseul_240625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49888;&#52404;&#54876;&#46041;\240603\PAF&#50836;&#51064;&#48324;&#44536;&#47548;&#44536;&#47532;&#44592;_DPA_Soseul_240625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49888;&#52404;&#54876;&#46041;\240603\PAF&#50836;&#51064;&#48324;&#44536;&#47548;&#44536;&#47532;&#44592;_DPA_Soseul_240625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587B-43D5-810E-EF22449615BB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587B-43D5-810E-EF22449615BB}"/>
              </c:ext>
            </c:extLst>
          </c:dPt>
          <c:dLbls>
            <c:dLbl>
              <c:idx val="0"/>
              <c:layout>
                <c:manualLayout>
                  <c:x val="-1.9123866254892253E-2"/>
                  <c:y val="0.14588590522484812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587B-43D5-810E-EF22449615BB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r>
                      <a:rPr lang="en-US" altLang="ko-KR" baseline="0" dirty="0"/>
                      <a:t>DPA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 dirty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587B-43D5-810E-EF22449615BB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녀_2020_I!$A$1:$A$2</c:f>
              <c:strCache>
                <c:ptCount val="2"/>
                <c:pt idx="0">
                  <c:v>Others</c:v>
                </c:pt>
                <c:pt idx="1">
                  <c:v>Smoking</c:v>
                </c:pt>
              </c:strCache>
            </c:strRef>
          </c:cat>
          <c:val>
            <c:numRef>
              <c:f>남녀_2020_I!$B$1:$B$2</c:f>
              <c:numCache>
                <c:formatCode>General</c:formatCode>
                <c:ptCount val="2"/>
                <c:pt idx="0">
                  <c:v>99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87B-43D5-810E-EF22449615BB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94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450D-4C94-8E20-C5DE76719F63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450D-4C94-8E20-C5DE76719F63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450D-4C94-8E20-C5DE76719F63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FB5C3BA5-E124-41DF-B720-E2ADB53DBE1E}" type="PERCENTAG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450D-4C94-8E20-C5DE76719F63}"/>
                </c:ext>
              </c:extLst>
            </c:dLbl>
            <c:dLbl>
              <c:idx val="1"/>
              <c:layout>
                <c:manualLayout>
                  <c:x val="-3.1235841823641673E-2"/>
                  <c:y val="0.10793324423426198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450D-4C94-8E20-C5DE76719F63}"/>
                </c:ext>
              </c:extLst>
            </c:dLbl>
            <c:dLbl>
              <c:idx val="2"/>
              <c:layout>
                <c:manualLayout>
                  <c:x val="0"/>
                  <c:y val="-1.557468598459148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450D-4C94-8E20-C5DE76719F63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녀_2020_I!$A$5:$A$7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남녀_2020_I!$B$5:$B$7</c:f>
              <c:numCache>
                <c:formatCode>General</c:formatCode>
                <c:ptCount val="3"/>
                <c:pt idx="0">
                  <c:v>1915</c:v>
                </c:pt>
                <c:pt idx="1">
                  <c:v>444</c:v>
                </c:pt>
                <c:pt idx="2">
                  <c:v>1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50D-4C94-8E20-C5DE76719F63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CFE3-4482-BE01-DDCF0D4EF979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CFE3-4482-BE01-DDCF0D4EF979}"/>
              </c:ext>
            </c:extLst>
          </c:dPt>
          <c:dLbls>
            <c:dLbl>
              <c:idx val="0"/>
              <c:layout>
                <c:manualLayout>
                  <c:x val="-1.6696991912530601E-2"/>
                  <c:y val="2.0471340573188536E-2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b="1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b="1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b="1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CFE3-4482-BE01-DDCF0D4EF979}"/>
                </c:ext>
              </c:extLst>
            </c:dLbl>
            <c:dLbl>
              <c:idx val="1"/>
              <c:layout>
                <c:manualLayout>
                  <c:x val="-2.6330706206126719E-2"/>
                  <c:y val="0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r>
                      <a:rPr lang="en-US" altLang="ko-KR" baseline="0" dirty="0"/>
                      <a:t>DPA </a:t>
                    </a:r>
                    <a:fld id="{28FCF578-7890-4DCD-84F5-5B7E3D09DAC3}" type="PERCENTAGE">
                      <a:rPr lang="en-US" altLang="ko-KR" baseline="0"/>
                      <a:pPr>
                        <a:defRPr sz="700" b="1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 dirty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3631385870072271"/>
                      <c:h val="0.14001469970600589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CFE3-4482-BE01-DDCF0D4EF979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prstDash val="solid"/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자_2020_I!$A$1:$A$2</c:f>
              <c:strCache>
                <c:ptCount val="2"/>
                <c:pt idx="0">
                  <c:v>Others</c:v>
                </c:pt>
                <c:pt idx="1">
                  <c:v>Smoking</c:v>
                </c:pt>
              </c:strCache>
            </c:strRef>
          </c:cat>
          <c:val>
            <c:numRef>
              <c:f>남자_2020_I!$B$1:$B$2</c:f>
              <c:numCache>
                <c:formatCode>General</c:formatCode>
                <c:ptCount val="2"/>
                <c:pt idx="0">
                  <c:v>99.6</c:v>
                </c:pt>
                <c:pt idx="1">
                  <c:v>0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FE3-4482-BE01-DDCF0D4EF979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93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prstDash val="solid"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84BC-4F08-BB00-C0B589B90737}"/>
              </c:ext>
            </c:extLst>
          </c:dPt>
          <c:dLbls>
            <c:dLbl>
              <c:idx val="0"/>
              <c:layout>
                <c:manualLayout>
                  <c:x val="0.2578697370041575"/>
                  <c:y val="-4.2884858120300677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A3FE1561-3EAD-41AB-BD00-C6F90790CAA7}" type="PERCENTAG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84BC-4F08-BB00-C0B589B90737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자_2020_I!$A$5</c:f>
              <c:strCache>
                <c:ptCount val="1"/>
                <c:pt idx="0">
                  <c:v>Colorectal</c:v>
                </c:pt>
              </c:strCache>
            </c:strRef>
          </c:cat>
          <c:val>
            <c:numRef>
              <c:f>남자_2020_I!$B$5</c:f>
              <c:numCache>
                <c:formatCode>General</c:formatCode>
                <c:ptCount val="1"/>
                <c:pt idx="0">
                  <c:v>5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4BC-4F08-BB00-C0B589B90737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F75B-4B0E-8E33-6AA2A194EFCF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F75B-4B0E-8E33-6AA2A194EFCF}"/>
              </c:ext>
            </c:extLst>
          </c:dPt>
          <c:dLbls>
            <c:dLbl>
              <c:idx val="0"/>
              <c:layout>
                <c:manualLayout>
                  <c:x val="5.4630542865811878E-2"/>
                  <c:y val="-0.26685603564662963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F75B-4B0E-8E33-6AA2A194EFCF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r>
                      <a:rPr lang="en-US" altLang="ko-KR" baseline="0" dirty="0"/>
                      <a:t>DPA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 dirty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F75B-4B0E-8E33-6AA2A194EFCF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여자_2020_I!$A$1:$A$2</c:f>
              <c:strCache>
                <c:ptCount val="2"/>
                <c:pt idx="0">
                  <c:v>Others</c:v>
                </c:pt>
                <c:pt idx="1">
                  <c:v>Smoking</c:v>
                </c:pt>
              </c:strCache>
            </c:strRef>
          </c:cat>
          <c:val>
            <c:numRef>
              <c:f>여자_2020_I!$B$1:$B$2</c:f>
              <c:numCache>
                <c:formatCode>General</c:formatCode>
                <c:ptCount val="2"/>
                <c:pt idx="0">
                  <c:v>98.3</c:v>
                </c:pt>
                <c:pt idx="1">
                  <c:v>1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75B-4B0E-8E33-6AA2A194EFCF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94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FC3D-45FA-8942-201CFCE753AA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FC3D-45FA-8942-201CFCE753AA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FC3D-45FA-8942-201CFCE753AA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D9FDD48B-1BD8-481F-AFCC-9569A4C021F3}" type="PERCENTAG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FC3D-45FA-8942-201CFCE753AA}"/>
                </c:ext>
              </c:extLst>
            </c:dLbl>
            <c:dLbl>
              <c:idx val="1"/>
              <c:layout>
                <c:manualLayout>
                  <c:x val="2.6403382301627698E-3"/>
                  <c:y val="0.23242399802391658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FC3D-45FA-8942-201CFCE753AA}"/>
                </c:ext>
              </c:extLst>
            </c:dLbl>
            <c:dLbl>
              <c:idx val="2"/>
              <c:layout>
                <c:manualLayout>
                  <c:x val="-2.9655852010293148E-2"/>
                  <c:y val="-1.557482600713696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FC3D-45FA-8942-201CFCE753AA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여자_2020_I!$A$5:$A$7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여자_2020_I!$B$5:$B$7</c:f>
              <c:numCache>
                <c:formatCode>General</c:formatCode>
                <c:ptCount val="3"/>
                <c:pt idx="0">
                  <c:v>1354</c:v>
                </c:pt>
                <c:pt idx="1">
                  <c:v>444</c:v>
                </c:pt>
                <c:pt idx="2">
                  <c:v>1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C3D-45FA-8942-201CFCE753AA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2889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41848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7110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7356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48971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4662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09270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8824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0463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36558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13221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4248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그룹 5">
            <a:extLst>
              <a:ext uri="{FF2B5EF4-FFF2-40B4-BE49-F238E27FC236}">
                <a16:creationId xmlns:a16="http://schemas.microsoft.com/office/drawing/2014/main" id="{BB8467F8-485C-455A-82BB-6E0544E0B4E2}"/>
              </a:ext>
            </a:extLst>
          </p:cNvPr>
          <p:cNvGrpSpPr/>
          <p:nvPr/>
        </p:nvGrpSpPr>
        <p:grpSpPr>
          <a:xfrm>
            <a:off x="494253" y="255609"/>
            <a:ext cx="5747445" cy="9472470"/>
            <a:chOff x="407645" y="524786"/>
            <a:chExt cx="5747445" cy="9472470"/>
          </a:xfrm>
        </p:grpSpPr>
        <p:sp>
          <p:nvSpPr>
            <p:cNvPr id="53" name="직사각형 52">
              <a:extLst>
                <a:ext uri="{FF2B5EF4-FFF2-40B4-BE49-F238E27FC236}">
                  <a16:creationId xmlns:a16="http://schemas.microsoft.com/office/drawing/2014/main" id="{E9FFEC05-C143-45B5-A6AA-E9F7914DFFBF}"/>
                </a:ext>
              </a:extLst>
            </p:cNvPr>
            <p:cNvSpPr/>
            <p:nvPr/>
          </p:nvSpPr>
          <p:spPr>
            <a:xfrm>
              <a:off x="466167" y="9443258"/>
              <a:ext cx="5630400" cy="553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Material 9. The population attributable fraction (%) of cancer cases attributed to deficit in physical activity (DPA) and proportion of specific cancers among all-cancer cases caused by DPA in Korea, 2020.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id="{603A60ED-922C-467C-B1AE-8BDDBE0CD9E1}"/>
                </a:ext>
              </a:extLst>
            </p:cNvPr>
            <p:cNvGrpSpPr/>
            <p:nvPr/>
          </p:nvGrpSpPr>
          <p:grpSpPr>
            <a:xfrm>
              <a:off x="407645" y="524786"/>
              <a:ext cx="5747445" cy="8786309"/>
              <a:chOff x="515253" y="524786"/>
              <a:chExt cx="5747445" cy="8786309"/>
            </a:xfrm>
          </p:grpSpPr>
          <p:grpSp>
            <p:nvGrpSpPr>
              <p:cNvPr id="4" name="그룹 3">
                <a:extLst>
                  <a:ext uri="{FF2B5EF4-FFF2-40B4-BE49-F238E27FC236}">
                    <a16:creationId xmlns:a16="http://schemas.microsoft.com/office/drawing/2014/main" id="{083B4796-10D6-4E64-A534-0BB7DC0844C2}"/>
                  </a:ext>
                </a:extLst>
              </p:cNvPr>
              <p:cNvGrpSpPr/>
              <p:nvPr/>
            </p:nvGrpSpPr>
            <p:grpSpPr>
              <a:xfrm>
                <a:off x="515253" y="524786"/>
                <a:ext cx="5734621" cy="2918100"/>
                <a:chOff x="515253" y="524786"/>
                <a:chExt cx="5734621" cy="2918100"/>
              </a:xfrm>
            </p:grpSpPr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ED0E3951-E7A8-4D37-953A-49C87951C1DC}"/>
                    </a:ext>
                  </a:extLst>
                </p:cNvPr>
                <p:cNvSpPr txBox="1"/>
                <p:nvPr/>
              </p:nvSpPr>
              <p:spPr>
                <a:xfrm>
                  <a:off x="515253" y="587120"/>
                  <a:ext cx="150554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otal cancer cases, 2020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29" name="그룹 28">
                  <a:extLst>
                    <a:ext uri="{FF2B5EF4-FFF2-40B4-BE49-F238E27FC236}">
                      <a16:creationId xmlns:a16="http://schemas.microsoft.com/office/drawing/2014/main" id="{686B247B-C4E1-410C-98AF-0861B8E63AD9}"/>
                    </a:ext>
                  </a:extLst>
                </p:cNvPr>
                <p:cNvGrpSpPr/>
                <p:nvPr/>
              </p:nvGrpSpPr>
              <p:grpSpPr>
                <a:xfrm>
                  <a:off x="554761" y="524786"/>
                  <a:ext cx="5695113" cy="2918100"/>
                  <a:chOff x="0" y="0"/>
                  <a:chExt cx="5674093" cy="2889196"/>
                </a:xfrm>
              </p:grpSpPr>
              <p:grpSp>
                <p:nvGrpSpPr>
                  <p:cNvPr id="30" name="그룹 29">
                    <a:extLst>
                      <a:ext uri="{FF2B5EF4-FFF2-40B4-BE49-F238E27FC236}">
                        <a16:creationId xmlns:a16="http://schemas.microsoft.com/office/drawing/2014/main" id="{6C99AEE4-EB82-4125-8D4E-F6A260C9F1EA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5674093" cy="2889196"/>
                    <a:chOff x="0" y="0"/>
                    <a:chExt cx="6113798" cy="3579573"/>
                  </a:xfrm>
                </p:grpSpPr>
                <p:grpSp>
                  <p:nvGrpSpPr>
                    <p:cNvPr id="32" name="그룹 31">
                      <a:extLst>
                        <a:ext uri="{FF2B5EF4-FFF2-40B4-BE49-F238E27FC236}">
                          <a16:creationId xmlns:a16="http://schemas.microsoft.com/office/drawing/2014/main" id="{9F241C43-852D-4BB1-858C-D67D3DD1189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0"/>
                      <a:ext cx="6113798" cy="3579573"/>
                      <a:chOff x="0" y="0"/>
                      <a:chExt cx="11105322" cy="4138820"/>
                    </a:xfrm>
                  </p:grpSpPr>
                  <p:graphicFrame>
                    <p:nvGraphicFramePr>
                      <p:cNvPr id="34" name="차트 33">
                        <a:extLst>
                          <a:ext uri="{FF2B5EF4-FFF2-40B4-BE49-F238E27FC236}">
                            <a16:creationId xmlns:a16="http://schemas.microsoft.com/office/drawing/2014/main" id="{F6029575-E857-4735-971F-F45A53E009BA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0" y="652478"/>
                      <a:ext cx="4681538" cy="2833864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2"/>
                      </a:graphicData>
                    </a:graphic>
                  </p:graphicFrame>
                  <p:graphicFrame>
                    <p:nvGraphicFramePr>
                      <p:cNvPr id="35" name="차트 34">
                        <a:extLst>
                          <a:ext uri="{FF2B5EF4-FFF2-40B4-BE49-F238E27FC236}">
                            <a16:creationId xmlns:a16="http://schemas.microsoft.com/office/drawing/2014/main" id="{4A7E19EF-8DA8-46B4-9F47-882CB1BF6C8A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5273414" y="0"/>
                      <a:ext cx="5831908" cy="413882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3"/>
                      </a:graphicData>
                    </a:graphic>
                  </p:graphicFrame>
                </p:grpSp>
                <p:cxnSp>
                  <p:nvCxnSpPr>
                    <p:cNvPr id="33" name="직선 연결선 32">
                      <a:extLst>
                        <a:ext uri="{FF2B5EF4-FFF2-40B4-BE49-F238E27FC236}">
                          <a16:creationId xmlns:a16="http://schemas.microsoft.com/office/drawing/2014/main" id="{1E24B20F-8019-409D-AC12-E9946335F39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134664" y="2032180"/>
                      <a:ext cx="2021577" cy="1163881"/>
                    </a:xfrm>
                    <a:prstGeom prst="line">
                      <a:avLst/>
                    </a:prstGeom>
                    <a:ln>
                      <a:solidFill>
                        <a:schemeClr val="accent3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31" name="직선 연결선 30">
                    <a:extLst>
                      <a:ext uri="{FF2B5EF4-FFF2-40B4-BE49-F238E27FC236}">
                        <a16:creationId xmlns:a16="http://schemas.microsoft.com/office/drawing/2014/main" id="{7C076E2B-5996-49AA-898D-8215EC4D0CF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1974570" y="302172"/>
                    <a:ext cx="1872305" cy="989915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3" name="그룹 2">
                <a:extLst>
                  <a:ext uri="{FF2B5EF4-FFF2-40B4-BE49-F238E27FC236}">
                    <a16:creationId xmlns:a16="http://schemas.microsoft.com/office/drawing/2014/main" id="{9A98FBBD-8DFE-412A-8193-6ECBDB2C44CE}"/>
                  </a:ext>
                </a:extLst>
              </p:cNvPr>
              <p:cNvGrpSpPr/>
              <p:nvPr/>
            </p:nvGrpSpPr>
            <p:grpSpPr>
              <a:xfrm>
                <a:off x="515253" y="3503264"/>
                <a:ext cx="5747445" cy="2921032"/>
                <a:chOff x="515253" y="3503264"/>
                <a:chExt cx="5747445" cy="2921032"/>
              </a:xfrm>
            </p:grpSpPr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258A911A-63B4-40A6-978C-8464EFBD17F1}"/>
                    </a:ext>
                  </a:extLst>
                </p:cNvPr>
                <p:cNvSpPr txBox="1"/>
                <p:nvPr/>
              </p:nvSpPr>
              <p:spPr>
                <a:xfrm>
                  <a:off x="515253" y="3545704"/>
                  <a:ext cx="149271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le cancer cases, 2020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36" name="그룹 35">
                  <a:extLst>
                    <a:ext uri="{FF2B5EF4-FFF2-40B4-BE49-F238E27FC236}">
                      <a16:creationId xmlns:a16="http://schemas.microsoft.com/office/drawing/2014/main" id="{33A72F46-27BD-4903-9009-8D9A8FFB16FA}"/>
                    </a:ext>
                  </a:extLst>
                </p:cNvPr>
                <p:cNvGrpSpPr/>
                <p:nvPr/>
              </p:nvGrpSpPr>
              <p:grpSpPr>
                <a:xfrm>
                  <a:off x="541937" y="3503264"/>
                  <a:ext cx="5720761" cy="2921032"/>
                  <a:chOff x="0" y="0"/>
                  <a:chExt cx="5720761" cy="2921032"/>
                </a:xfrm>
              </p:grpSpPr>
              <p:grpSp>
                <p:nvGrpSpPr>
                  <p:cNvPr id="37" name="그룹 36">
                    <a:extLst>
                      <a:ext uri="{FF2B5EF4-FFF2-40B4-BE49-F238E27FC236}">
                        <a16:creationId xmlns:a16="http://schemas.microsoft.com/office/drawing/2014/main" id="{7EF9672D-9316-4731-97BD-50237F3D8158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5720761" cy="2921032"/>
                    <a:chOff x="0" y="0"/>
                    <a:chExt cx="5695116" cy="3251851"/>
                  </a:xfrm>
                </p:grpSpPr>
                <p:grpSp>
                  <p:nvGrpSpPr>
                    <p:cNvPr id="39" name="그룹 38">
                      <a:extLst>
                        <a:ext uri="{FF2B5EF4-FFF2-40B4-BE49-F238E27FC236}">
                          <a16:creationId xmlns:a16="http://schemas.microsoft.com/office/drawing/2014/main" id="{E37B7680-E178-403F-AA97-B1D1AE3304B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0"/>
                      <a:ext cx="5695116" cy="3251851"/>
                      <a:chOff x="0" y="0"/>
                      <a:chExt cx="11105322" cy="4138820"/>
                    </a:xfrm>
                  </p:grpSpPr>
                  <p:graphicFrame>
                    <p:nvGraphicFramePr>
                      <p:cNvPr id="41" name="차트 40">
                        <a:extLst>
                          <a:ext uri="{FF2B5EF4-FFF2-40B4-BE49-F238E27FC236}">
                            <a16:creationId xmlns:a16="http://schemas.microsoft.com/office/drawing/2014/main" id="{EB55C681-E35B-43F9-936E-05DF1A3F137F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0" y="652478"/>
                      <a:ext cx="4681538" cy="2833864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4"/>
                      </a:graphicData>
                    </a:graphic>
                  </p:graphicFrame>
                  <p:graphicFrame>
                    <p:nvGraphicFramePr>
                      <p:cNvPr id="42" name="차트 41">
                        <a:extLst>
                          <a:ext uri="{FF2B5EF4-FFF2-40B4-BE49-F238E27FC236}">
                            <a16:creationId xmlns:a16="http://schemas.microsoft.com/office/drawing/2014/main" id="{C6B0431D-7CF7-495F-941F-2D4E1535F3E1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5273413" y="0"/>
                      <a:ext cx="5831909" cy="413882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5"/>
                      </a:graphicData>
                    </a:graphic>
                  </p:graphicFrame>
                </p:grpSp>
                <p:cxnSp>
                  <p:nvCxnSpPr>
                    <p:cNvPr id="40" name="직선 연결선 39">
                      <a:extLst>
                        <a:ext uri="{FF2B5EF4-FFF2-40B4-BE49-F238E27FC236}">
                          <a16:creationId xmlns:a16="http://schemas.microsoft.com/office/drawing/2014/main" id="{BCF13802-6FBC-436C-BEF2-C2DEAF4B928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03648" y="1834078"/>
                      <a:ext cx="1794343" cy="1068531"/>
                    </a:xfrm>
                    <a:prstGeom prst="line">
                      <a:avLst/>
                    </a:prstGeom>
                    <a:ln>
                      <a:solidFill>
                        <a:schemeClr val="accent3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38" name="직선 연결선 37">
                    <a:extLst>
                      <a:ext uri="{FF2B5EF4-FFF2-40B4-BE49-F238E27FC236}">
                        <a16:creationId xmlns:a16="http://schemas.microsoft.com/office/drawing/2014/main" id="{88FE7D68-6820-4526-B677-EBDF8AF2557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000250" y="373673"/>
                    <a:ext cx="1802423" cy="959827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2" name="그룹 1">
                <a:extLst>
                  <a:ext uri="{FF2B5EF4-FFF2-40B4-BE49-F238E27FC236}">
                    <a16:creationId xmlns:a16="http://schemas.microsoft.com/office/drawing/2014/main" id="{F776F8B1-481C-4E21-9E64-A5D70D0C02F7}"/>
                  </a:ext>
                </a:extLst>
              </p:cNvPr>
              <p:cNvGrpSpPr/>
              <p:nvPr/>
            </p:nvGrpSpPr>
            <p:grpSpPr>
              <a:xfrm>
                <a:off x="518601" y="6484674"/>
                <a:ext cx="5726511" cy="2826421"/>
                <a:chOff x="518601" y="6484674"/>
                <a:chExt cx="5726511" cy="2826421"/>
              </a:xfrm>
            </p:grpSpPr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1CCE139B-33F4-42FE-852F-5255F617D6FF}"/>
                    </a:ext>
                  </a:extLst>
                </p:cNvPr>
                <p:cNvSpPr txBox="1"/>
                <p:nvPr/>
              </p:nvSpPr>
              <p:spPr>
                <a:xfrm>
                  <a:off x="518601" y="6504288"/>
                  <a:ext cx="16417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emale cancer cases, 2020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43" name="그룹 42">
                  <a:extLst>
                    <a:ext uri="{FF2B5EF4-FFF2-40B4-BE49-F238E27FC236}">
                      <a16:creationId xmlns:a16="http://schemas.microsoft.com/office/drawing/2014/main" id="{AA0FE6DA-288D-4E32-83D1-D47F187ABA33}"/>
                    </a:ext>
                  </a:extLst>
                </p:cNvPr>
                <p:cNvGrpSpPr/>
                <p:nvPr/>
              </p:nvGrpSpPr>
              <p:grpSpPr>
                <a:xfrm>
                  <a:off x="559522" y="6484674"/>
                  <a:ext cx="5685590" cy="2826421"/>
                  <a:chOff x="0" y="0"/>
                  <a:chExt cx="5708367" cy="3214577"/>
                </a:xfrm>
              </p:grpSpPr>
              <p:grpSp>
                <p:nvGrpSpPr>
                  <p:cNvPr id="44" name="그룹 43">
                    <a:extLst>
                      <a:ext uri="{FF2B5EF4-FFF2-40B4-BE49-F238E27FC236}">
                        <a16:creationId xmlns:a16="http://schemas.microsoft.com/office/drawing/2014/main" id="{D7CF2999-7913-41E9-A395-CC0881C85621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5708367" cy="3214577"/>
                    <a:chOff x="0" y="0"/>
                    <a:chExt cx="11105322" cy="4138820"/>
                  </a:xfrm>
                </p:grpSpPr>
                <p:graphicFrame>
                  <p:nvGraphicFramePr>
                    <p:cNvPr id="50" name="차트 49">
                      <a:extLst>
                        <a:ext uri="{FF2B5EF4-FFF2-40B4-BE49-F238E27FC236}">
                          <a16:creationId xmlns:a16="http://schemas.microsoft.com/office/drawing/2014/main" id="{C7D17774-2323-4C2A-BCC2-BE1A887639B7}"/>
                        </a:ext>
                      </a:extLst>
                    </p:cNvPr>
                    <p:cNvGraphicFramePr>
                      <a:graphicFrameLocks/>
                    </p:cNvGraphicFramePr>
                    <p:nvPr/>
                  </p:nvGraphicFramePr>
                  <p:xfrm>
                    <a:off x="0" y="652478"/>
                    <a:ext cx="4681538" cy="2833864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6"/>
                    </a:graphicData>
                  </a:graphic>
                </p:graphicFrame>
                <p:graphicFrame>
                  <p:nvGraphicFramePr>
                    <p:cNvPr id="51" name="차트 50">
                      <a:extLst>
                        <a:ext uri="{FF2B5EF4-FFF2-40B4-BE49-F238E27FC236}">
                          <a16:creationId xmlns:a16="http://schemas.microsoft.com/office/drawing/2014/main" id="{551428A4-3368-4858-B0E4-58F93BF5C689}"/>
                        </a:ext>
                      </a:extLst>
                    </p:cNvPr>
                    <p:cNvGraphicFramePr>
                      <a:graphicFrameLocks/>
                    </p:cNvGraphicFramePr>
                    <p:nvPr/>
                  </p:nvGraphicFramePr>
                  <p:xfrm>
                    <a:off x="5273414" y="0"/>
                    <a:ext cx="5831908" cy="4138820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7"/>
                    </a:graphicData>
                  </a:graphic>
                </p:graphicFrame>
              </p:grpSp>
              <p:cxnSp>
                <p:nvCxnSpPr>
                  <p:cNvPr id="45" name="직선 연결선 44">
                    <a:extLst>
                      <a:ext uri="{FF2B5EF4-FFF2-40B4-BE49-F238E27FC236}">
                        <a16:creationId xmlns:a16="http://schemas.microsoft.com/office/drawing/2014/main" id="{30DA4FCA-6EBB-4D4A-8B8B-0BE1DF4EE28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042250" y="370430"/>
                    <a:ext cx="1829564" cy="1084160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9" name="직선 연결선 48">
                    <a:extLst>
                      <a:ext uri="{FF2B5EF4-FFF2-40B4-BE49-F238E27FC236}">
                        <a16:creationId xmlns:a16="http://schemas.microsoft.com/office/drawing/2014/main" id="{B9163AF9-ABB7-4BCF-8E6F-060CE3C4FB1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18342" y="1732186"/>
                    <a:ext cx="1864001" cy="1108186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</p:spTree>
    <p:extLst>
      <p:ext uri="{BB962C8B-B14F-4D97-AF65-F5344CB8AC3E}">
        <p14:creationId xmlns:p14="http://schemas.microsoft.com/office/powerpoint/2010/main" val="3378386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05</TotalTime>
  <Words>85</Words>
  <Application>Microsoft Office PowerPoint</Application>
  <PresentationFormat>A4 용지(210x297mm)</PresentationFormat>
  <Paragraphs>2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oseul Sung</dc:creator>
  <cp:lastModifiedBy>이제인</cp:lastModifiedBy>
  <cp:revision>131</cp:revision>
  <dcterms:created xsi:type="dcterms:W3CDTF">2024-07-11T07:58:49Z</dcterms:created>
  <dcterms:modified xsi:type="dcterms:W3CDTF">2025-09-25T00:27:18Z</dcterms:modified>
</cp:coreProperties>
</file>